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7" r:id="rId2"/>
  </p:sldIdLst>
  <p:sldSz cx="12192000" cy="9018588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17" autoAdjust="0"/>
    <p:restoredTop sz="81680" autoAdjust="0"/>
  </p:normalViewPr>
  <p:slideViewPr>
    <p:cSldViewPr snapToGrid="0">
      <p:cViewPr varScale="1">
        <p:scale>
          <a:sx n="77" d="100"/>
          <a:sy n="77" d="100"/>
        </p:scale>
        <p:origin x="1944" y="2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3BF66E-C1ED-4FF9-BCB1-B7CA59F6761E}" type="datetimeFigureOut">
              <a:rPr lang="en-IN" smtClean="0"/>
              <a:t>03/02/23</a:t>
            </a:fld>
            <a:endParaRPr lang="en-IN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43025" y="1143000"/>
            <a:ext cx="41719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IN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CF258A-5AB0-456E-80B3-E1836667E3B2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69064944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1343025" y="1143000"/>
            <a:ext cx="417195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IN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DCF258A-5AB0-456E-80B3-E1836667E3B2}" type="slidenum">
              <a:rPr lang="en-IN" smtClean="0"/>
              <a:t>1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5251414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475959"/>
            <a:ext cx="10363200" cy="3139805"/>
          </a:xfrm>
        </p:spPr>
        <p:txBody>
          <a:bodyPr anchor="b"/>
          <a:lstStyle>
            <a:lvl1pPr algn="ctr">
              <a:defRPr sz="789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4736847"/>
            <a:ext cx="9144000" cy="2177404"/>
          </a:xfrm>
        </p:spPr>
        <p:txBody>
          <a:bodyPr/>
          <a:lstStyle>
            <a:lvl1pPr marL="0" indent="0" algn="ctr">
              <a:buNone/>
              <a:defRPr sz="3156"/>
            </a:lvl1pPr>
            <a:lvl2pPr marL="601218" indent="0" algn="ctr">
              <a:buNone/>
              <a:defRPr sz="2630"/>
            </a:lvl2pPr>
            <a:lvl3pPr marL="1202436" indent="0" algn="ctr">
              <a:buNone/>
              <a:defRPr sz="2367"/>
            </a:lvl3pPr>
            <a:lvl4pPr marL="1803654" indent="0" algn="ctr">
              <a:buNone/>
              <a:defRPr sz="2104"/>
            </a:lvl4pPr>
            <a:lvl5pPr marL="2404872" indent="0" algn="ctr">
              <a:buNone/>
              <a:defRPr sz="2104"/>
            </a:lvl5pPr>
            <a:lvl6pPr marL="3006090" indent="0" algn="ctr">
              <a:buNone/>
              <a:defRPr sz="2104"/>
            </a:lvl6pPr>
            <a:lvl7pPr marL="3607308" indent="0" algn="ctr">
              <a:buNone/>
              <a:defRPr sz="2104"/>
            </a:lvl7pPr>
            <a:lvl8pPr marL="4208526" indent="0" algn="ctr">
              <a:buNone/>
              <a:defRPr sz="2104"/>
            </a:lvl8pPr>
            <a:lvl9pPr marL="4809744" indent="0" algn="ctr">
              <a:buNone/>
              <a:defRPr sz="2104"/>
            </a:lvl9pPr>
          </a:lstStyle>
          <a:p>
            <a:r>
              <a:rPr lang="en-GB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E39EB1-F31A-49BA-9AA2-98235D211AAF}" type="datetimeFigureOut">
              <a:rPr lang="en-IN" smtClean="0"/>
              <a:t>03/02/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4DC41-86FC-41BD-8365-5FC4F498B7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091733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E39EB1-F31A-49BA-9AA2-98235D211AAF}" type="datetimeFigureOut">
              <a:rPr lang="en-IN" smtClean="0"/>
              <a:t>03/02/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4DC41-86FC-41BD-8365-5FC4F498B7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9323082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1" y="480157"/>
            <a:ext cx="2628900" cy="7642836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1" y="480157"/>
            <a:ext cx="7734300" cy="7642836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E39EB1-F31A-49BA-9AA2-98235D211AAF}" type="datetimeFigureOut">
              <a:rPr lang="en-IN" smtClean="0"/>
              <a:t>03/02/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4DC41-86FC-41BD-8365-5FC4F498B7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45156073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E39EB1-F31A-49BA-9AA2-98235D211AAF}" type="datetimeFigureOut">
              <a:rPr lang="en-IN" smtClean="0"/>
              <a:t>03/02/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4DC41-86FC-41BD-8365-5FC4F498B7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0617787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1" y="2248387"/>
            <a:ext cx="10515600" cy="3751481"/>
          </a:xfrm>
        </p:spPr>
        <p:txBody>
          <a:bodyPr anchor="b"/>
          <a:lstStyle>
            <a:lvl1pPr>
              <a:defRPr sz="7890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1" y="6035359"/>
            <a:ext cx="10515600" cy="1972815"/>
          </a:xfrm>
        </p:spPr>
        <p:txBody>
          <a:bodyPr/>
          <a:lstStyle>
            <a:lvl1pPr marL="0" indent="0">
              <a:buNone/>
              <a:defRPr sz="3156">
                <a:solidFill>
                  <a:schemeClr val="tx1"/>
                </a:solidFill>
              </a:defRPr>
            </a:lvl1pPr>
            <a:lvl2pPr marL="601218" indent="0">
              <a:buNone/>
              <a:defRPr sz="2630">
                <a:solidFill>
                  <a:schemeClr val="tx1">
                    <a:tint val="75000"/>
                  </a:schemeClr>
                </a:solidFill>
              </a:defRPr>
            </a:lvl2pPr>
            <a:lvl3pPr marL="1202436" indent="0">
              <a:buNone/>
              <a:defRPr sz="2367">
                <a:solidFill>
                  <a:schemeClr val="tx1">
                    <a:tint val="75000"/>
                  </a:schemeClr>
                </a:solidFill>
              </a:defRPr>
            </a:lvl3pPr>
            <a:lvl4pPr marL="1803654" indent="0">
              <a:buNone/>
              <a:defRPr sz="2104">
                <a:solidFill>
                  <a:schemeClr val="tx1">
                    <a:tint val="75000"/>
                  </a:schemeClr>
                </a:solidFill>
              </a:defRPr>
            </a:lvl4pPr>
            <a:lvl5pPr marL="2404872" indent="0">
              <a:buNone/>
              <a:defRPr sz="2104">
                <a:solidFill>
                  <a:schemeClr val="tx1">
                    <a:tint val="75000"/>
                  </a:schemeClr>
                </a:solidFill>
              </a:defRPr>
            </a:lvl5pPr>
            <a:lvl6pPr marL="3006090" indent="0">
              <a:buNone/>
              <a:defRPr sz="2104">
                <a:solidFill>
                  <a:schemeClr val="tx1">
                    <a:tint val="75000"/>
                  </a:schemeClr>
                </a:solidFill>
              </a:defRPr>
            </a:lvl6pPr>
            <a:lvl7pPr marL="3607308" indent="0">
              <a:buNone/>
              <a:defRPr sz="2104">
                <a:solidFill>
                  <a:schemeClr val="tx1">
                    <a:tint val="75000"/>
                  </a:schemeClr>
                </a:solidFill>
              </a:defRPr>
            </a:lvl7pPr>
            <a:lvl8pPr marL="4208526" indent="0">
              <a:buNone/>
              <a:defRPr sz="2104">
                <a:solidFill>
                  <a:schemeClr val="tx1">
                    <a:tint val="75000"/>
                  </a:schemeClr>
                </a:solidFill>
              </a:defRPr>
            </a:lvl8pPr>
            <a:lvl9pPr marL="4809744" indent="0">
              <a:buNone/>
              <a:defRPr sz="2104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E39EB1-F31A-49BA-9AA2-98235D211AAF}" type="datetimeFigureOut">
              <a:rPr lang="en-IN" smtClean="0"/>
              <a:t>03/02/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4DC41-86FC-41BD-8365-5FC4F498B7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26453379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2400782"/>
            <a:ext cx="5181600" cy="5722211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2400782"/>
            <a:ext cx="5181600" cy="5722211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E39EB1-F31A-49BA-9AA2-98235D211AAF}" type="datetimeFigureOut">
              <a:rPr lang="en-IN" smtClean="0"/>
              <a:t>03/02/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4DC41-86FC-41BD-8365-5FC4F498B7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426626985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80158"/>
            <a:ext cx="10515600" cy="1743177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9" y="2210808"/>
            <a:ext cx="5157787" cy="1083482"/>
          </a:xfrm>
        </p:spPr>
        <p:txBody>
          <a:bodyPr anchor="b"/>
          <a:lstStyle>
            <a:lvl1pPr marL="0" indent="0">
              <a:buNone/>
              <a:defRPr sz="3156" b="1"/>
            </a:lvl1pPr>
            <a:lvl2pPr marL="601218" indent="0">
              <a:buNone/>
              <a:defRPr sz="2630" b="1"/>
            </a:lvl2pPr>
            <a:lvl3pPr marL="1202436" indent="0">
              <a:buNone/>
              <a:defRPr sz="2367" b="1"/>
            </a:lvl3pPr>
            <a:lvl4pPr marL="1803654" indent="0">
              <a:buNone/>
              <a:defRPr sz="2104" b="1"/>
            </a:lvl4pPr>
            <a:lvl5pPr marL="2404872" indent="0">
              <a:buNone/>
              <a:defRPr sz="2104" b="1"/>
            </a:lvl5pPr>
            <a:lvl6pPr marL="3006090" indent="0">
              <a:buNone/>
              <a:defRPr sz="2104" b="1"/>
            </a:lvl6pPr>
            <a:lvl7pPr marL="3607308" indent="0">
              <a:buNone/>
              <a:defRPr sz="2104" b="1"/>
            </a:lvl7pPr>
            <a:lvl8pPr marL="4208526" indent="0">
              <a:buNone/>
              <a:defRPr sz="2104" b="1"/>
            </a:lvl8pPr>
            <a:lvl9pPr marL="4809744" indent="0">
              <a:buNone/>
              <a:defRPr sz="2104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9" y="3294290"/>
            <a:ext cx="5157787" cy="484540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1" y="2210808"/>
            <a:ext cx="5183188" cy="1083482"/>
          </a:xfrm>
        </p:spPr>
        <p:txBody>
          <a:bodyPr anchor="b"/>
          <a:lstStyle>
            <a:lvl1pPr marL="0" indent="0">
              <a:buNone/>
              <a:defRPr sz="3156" b="1"/>
            </a:lvl1pPr>
            <a:lvl2pPr marL="601218" indent="0">
              <a:buNone/>
              <a:defRPr sz="2630" b="1"/>
            </a:lvl2pPr>
            <a:lvl3pPr marL="1202436" indent="0">
              <a:buNone/>
              <a:defRPr sz="2367" b="1"/>
            </a:lvl3pPr>
            <a:lvl4pPr marL="1803654" indent="0">
              <a:buNone/>
              <a:defRPr sz="2104" b="1"/>
            </a:lvl4pPr>
            <a:lvl5pPr marL="2404872" indent="0">
              <a:buNone/>
              <a:defRPr sz="2104" b="1"/>
            </a:lvl5pPr>
            <a:lvl6pPr marL="3006090" indent="0">
              <a:buNone/>
              <a:defRPr sz="2104" b="1"/>
            </a:lvl6pPr>
            <a:lvl7pPr marL="3607308" indent="0">
              <a:buNone/>
              <a:defRPr sz="2104" b="1"/>
            </a:lvl7pPr>
            <a:lvl8pPr marL="4208526" indent="0">
              <a:buNone/>
              <a:defRPr sz="2104" b="1"/>
            </a:lvl8pPr>
            <a:lvl9pPr marL="4809744" indent="0">
              <a:buNone/>
              <a:defRPr sz="2104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1" y="3294290"/>
            <a:ext cx="5183188" cy="4845404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E39EB1-F31A-49BA-9AA2-98235D211AAF}" type="datetimeFigureOut">
              <a:rPr lang="en-IN" smtClean="0"/>
              <a:t>03/02/23</a:t>
            </a:fld>
            <a:endParaRPr lang="en-IN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4DC41-86FC-41BD-8365-5FC4F498B7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9682792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E39EB1-F31A-49BA-9AA2-98235D211AAF}" type="datetimeFigureOut">
              <a:rPr lang="en-IN" smtClean="0"/>
              <a:t>03/02/23</a:t>
            </a:fld>
            <a:endParaRPr lang="en-IN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4DC41-86FC-41BD-8365-5FC4F498B7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12300769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E39EB1-F31A-49BA-9AA2-98235D211AAF}" type="datetimeFigureOut">
              <a:rPr lang="en-IN" smtClean="0"/>
              <a:t>03/02/23</a:t>
            </a:fld>
            <a:endParaRPr lang="en-IN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4DC41-86FC-41BD-8365-5FC4F498B7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2855387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1239"/>
            <a:ext cx="3932237" cy="2104337"/>
          </a:xfrm>
        </p:spPr>
        <p:txBody>
          <a:bodyPr anchor="b"/>
          <a:lstStyle>
            <a:lvl1pPr>
              <a:defRPr sz="4208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1298512"/>
            <a:ext cx="6172200" cy="6409043"/>
          </a:xfrm>
        </p:spPr>
        <p:txBody>
          <a:bodyPr/>
          <a:lstStyle>
            <a:lvl1pPr>
              <a:defRPr sz="4208"/>
            </a:lvl1pPr>
            <a:lvl2pPr>
              <a:defRPr sz="3682"/>
            </a:lvl2pPr>
            <a:lvl3pPr>
              <a:defRPr sz="3156"/>
            </a:lvl3pPr>
            <a:lvl4pPr>
              <a:defRPr sz="2630"/>
            </a:lvl4pPr>
            <a:lvl5pPr>
              <a:defRPr sz="2630"/>
            </a:lvl5pPr>
            <a:lvl6pPr>
              <a:defRPr sz="2630"/>
            </a:lvl6pPr>
            <a:lvl7pPr>
              <a:defRPr sz="2630"/>
            </a:lvl7pPr>
            <a:lvl8pPr>
              <a:defRPr sz="2630"/>
            </a:lvl8pPr>
            <a:lvl9pPr>
              <a:defRPr sz="263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05576"/>
            <a:ext cx="3932237" cy="5012415"/>
          </a:xfrm>
        </p:spPr>
        <p:txBody>
          <a:bodyPr/>
          <a:lstStyle>
            <a:lvl1pPr marL="0" indent="0">
              <a:buNone/>
              <a:defRPr sz="2104"/>
            </a:lvl1pPr>
            <a:lvl2pPr marL="601218" indent="0">
              <a:buNone/>
              <a:defRPr sz="1841"/>
            </a:lvl2pPr>
            <a:lvl3pPr marL="1202436" indent="0">
              <a:buNone/>
              <a:defRPr sz="1578"/>
            </a:lvl3pPr>
            <a:lvl4pPr marL="1803654" indent="0">
              <a:buNone/>
              <a:defRPr sz="1315"/>
            </a:lvl4pPr>
            <a:lvl5pPr marL="2404872" indent="0">
              <a:buNone/>
              <a:defRPr sz="1315"/>
            </a:lvl5pPr>
            <a:lvl6pPr marL="3006090" indent="0">
              <a:buNone/>
              <a:defRPr sz="1315"/>
            </a:lvl6pPr>
            <a:lvl7pPr marL="3607308" indent="0">
              <a:buNone/>
              <a:defRPr sz="1315"/>
            </a:lvl7pPr>
            <a:lvl8pPr marL="4208526" indent="0">
              <a:buNone/>
              <a:defRPr sz="1315"/>
            </a:lvl8pPr>
            <a:lvl9pPr marL="4809744" indent="0">
              <a:buNone/>
              <a:defRPr sz="1315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E39EB1-F31A-49BA-9AA2-98235D211AAF}" type="datetimeFigureOut">
              <a:rPr lang="en-IN" smtClean="0"/>
              <a:t>03/02/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4DC41-86FC-41BD-8365-5FC4F498B7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44193196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601239"/>
            <a:ext cx="3932237" cy="2104337"/>
          </a:xfrm>
        </p:spPr>
        <p:txBody>
          <a:bodyPr anchor="b"/>
          <a:lstStyle>
            <a:lvl1pPr>
              <a:defRPr sz="4208"/>
            </a:lvl1pPr>
          </a:lstStyle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183188" y="1298512"/>
            <a:ext cx="6172200" cy="6409043"/>
          </a:xfrm>
        </p:spPr>
        <p:txBody>
          <a:bodyPr anchor="t"/>
          <a:lstStyle>
            <a:lvl1pPr marL="0" indent="0">
              <a:buNone/>
              <a:defRPr sz="4208"/>
            </a:lvl1pPr>
            <a:lvl2pPr marL="601218" indent="0">
              <a:buNone/>
              <a:defRPr sz="3682"/>
            </a:lvl2pPr>
            <a:lvl3pPr marL="1202436" indent="0">
              <a:buNone/>
              <a:defRPr sz="3156"/>
            </a:lvl3pPr>
            <a:lvl4pPr marL="1803654" indent="0">
              <a:buNone/>
              <a:defRPr sz="2630"/>
            </a:lvl4pPr>
            <a:lvl5pPr marL="2404872" indent="0">
              <a:buNone/>
              <a:defRPr sz="2630"/>
            </a:lvl5pPr>
            <a:lvl6pPr marL="3006090" indent="0">
              <a:buNone/>
              <a:defRPr sz="2630"/>
            </a:lvl6pPr>
            <a:lvl7pPr marL="3607308" indent="0">
              <a:buNone/>
              <a:defRPr sz="2630"/>
            </a:lvl7pPr>
            <a:lvl8pPr marL="4208526" indent="0">
              <a:buNone/>
              <a:defRPr sz="2630"/>
            </a:lvl8pPr>
            <a:lvl9pPr marL="4809744" indent="0">
              <a:buNone/>
              <a:defRPr sz="2630"/>
            </a:lvl9pPr>
          </a:lstStyle>
          <a:p>
            <a:r>
              <a:rPr lang="en-GB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705576"/>
            <a:ext cx="3932237" cy="5012415"/>
          </a:xfrm>
        </p:spPr>
        <p:txBody>
          <a:bodyPr/>
          <a:lstStyle>
            <a:lvl1pPr marL="0" indent="0">
              <a:buNone/>
              <a:defRPr sz="2104"/>
            </a:lvl1pPr>
            <a:lvl2pPr marL="601218" indent="0">
              <a:buNone/>
              <a:defRPr sz="1841"/>
            </a:lvl2pPr>
            <a:lvl3pPr marL="1202436" indent="0">
              <a:buNone/>
              <a:defRPr sz="1578"/>
            </a:lvl3pPr>
            <a:lvl4pPr marL="1803654" indent="0">
              <a:buNone/>
              <a:defRPr sz="1315"/>
            </a:lvl4pPr>
            <a:lvl5pPr marL="2404872" indent="0">
              <a:buNone/>
              <a:defRPr sz="1315"/>
            </a:lvl5pPr>
            <a:lvl6pPr marL="3006090" indent="0">
              <a:buNone/>
              <a:defRPr sz="1315"/>
            </a:lvl6pPr>
            <a:lvl7pPr marL="3607308" indent="0">
              <a:buNone/>
              <a:defRPr sz="1315"/>
            </a:lvl7pPr>
            <a:lvl8pPr marL="4208526" indent="0">
              <a:buNone/>
              <a:defRPr sz="1315"/>
            </a:lvl8pPr>
            <a:lvl9pPr marL="4809744" indent="0">
              <a:buNone/>
              <a:defRPr sz="1315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DE39EB1-F31A-49BA-9AA2-98235D211AAF}" type="datetimeFigureOut">
              <a:rPr lang="en-IN" smtClean="0"/>
              <a:t>03/02/23</a:t>
            </a:fld>
            <a:endParaRPr lang="en-IN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IN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C34DC41-86FC-41BD-8365-5FC4F498B7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9526870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480158"/>
            <a:ext cx="10515600" cy="174317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2400782"/>
            <a:ext cx="10515600" cy="572221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8358897"/>
            <a:ext cx="2743200" cy="48015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57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DE39EB1-F31A-49BA-9AA2-98235D211AAF}" type="datetimeFigureOut">
              <a:rPr lang="en-IN" smtClean="0"/>
              <a:t>03/02/23</a:t>
            </a:fld>
            <a:endParaRPr lang="en-IN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8358897"/>
            <a:ext cx="4114800" cy="48015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57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IN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8358897"/>
            <a:ext cx="2743200" cy="480156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578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C34DC41-86FC-41BD-8365-5FC4F498B773}" type="slidenum">
              <a:rPr lang="en-IN" smtClean="0"/>
              <a:t>‹#›</a:t>
            </a:fld>
            <a:endParaRPr lang="en-IN"/>
          </a:p>
        </p:txBody>
      </p:sp>
    </p:spTree>
    <p:extLst>
      <p:ext uri="{BB962C8B-B14F-4D97-AF65-F5344CB8AC3E}">
        <p14:creationId xmlns:p14="http://schemas.microsoft.com/office/powerpoint/2010/main" val="311617856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1202436" rtl="0" eaLnBrk="1" latinLnBrk="0" hangingPunct="1">
        <a:lnSpc>
          <a:spcPct val="90000"/>
        </a:lnSpc>
        <a:spcBef>
          <a:spcPct val="0"/>
        </a:spcBef>
        <a:buNone/>
        <a:defRPr sz="5786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00609" indent="-300609" algn="l" defTabSz="1202436" rtl="0" eaLnBrk="1" latinLnBrk="0" hangingPunct="1">
        <a:lnSpc>
          <a:spcPct val="90000"/>
        </a:lnSpc>
        <a:spcBef>
          <a:spcPts val="1315"/>
        </a:spcBef>
        <a:buFont typeface="Arial" panose="020B0604020202020204" pitchFamily="34" charset="0"/>
        <a:buChar char="•"/>
        <a:defRPr sz="3682" kern="1200">
          <a:solidFill>
            <a:schemeClr val="tx1"/>
          </a:solidFill>
          <a:latin typeface="+mn-lt"/>
          <a:ea typeface="+mn-ea"/>
          <a:cs typeface="+mn-cs"/>
        </a:defRPr>
      </a:lvl1pPr>
      <a:lvl2pPr marL="901827" indent="-300609" algn="l" defTabSz="1202436" rtl="0" eaLnBrk="1" latinLnBrk="0" hangingPunct="1">
        <a:lnSpc>
          <a:spcPct val="90000"/>
        </a:lnSpc>
        <a:spcBef>
          <a:spcPts val="658"/>
        </a:spcBef>
        <a:buFont typeface="Arial" panose="020B0604020202020204" pitchFamily="34" charset="0"/>
        <a:buChar char="•"/>
        <a:defRPr sz="3156" kern="1200">
          <a:solidFill>
            <a:schemeClr val="tx1"/>
          </a:solidFill>
          <a:latin typeface="+mn-lt"/>
          <a:ea typeface="+mn-ea"/>
          <a:cs typeface="+mn-cs"/>
        </a:defRPr>
      </a:lvl2pPr>
      <a:lvl3pPr marL="1503045" indent="-300609" algn="l" defTabSz="1202436" rtl="0" eaLnBrk="1" latinLnBrk="0" hangingPunct="1">
        <a:lnSpc>
          <a:spcPct val="90000"/>
        </a:lnSpc>
        <a:spcBef>
          <a:spcPts val="658"/>
        </a:spcBef>
        <a:buFont typeface="Arial" panose="020B0604020202020204" pitchFamily="34" charset="0"/>
        <a:buChar char="•"/>
        <a:defRPr sz="2630" kern="1200">
          <a:solidFill>
            <a:schemeClr val="tx1"/>
          </a:solidFill>
          <a:latin typeface="+mn-lt"/>
          <a:ea typeface="+mn-ea"/>
          <a:cs typeface="+mn-cs"/>
        </a:defRPr>
      </a:lvl3pPr>
      <a:lvl4pPr marL="2104263" indent="-300609" algn="l" defTabSz="1202436" rtl="0" eaLnBrk="1" latinLnBrk="0" hangingPunct="1">
        <a:lnSpc>
          <a:spcPct val="90000"/>
        </a:lnSpc>
        <a:spcBef>
          <a:spcPts val="658"/>
        </a:spcBef>
        <a:buFont typeface="Arial" panose="020B0604020202020204" pitchFamily="34" charset="0"/>
        <a:buChar char="•"/>
        <a:defRPr sz="2367" kern="1200">
          <a:solidFill>
            <a:schemeClr val="tx1"/>
          </a:solidFill>
          <a:latin typeface="+mn-lt"/>
          <a:ea typeface="+mn-ea"/>
          <a:cs typeface="+mn-cs"/>
        </a:defRPr>
      </a:lvl4pPr>
      <a:lvl5pPr marL="2705481" indent="-300609" algn="l" defTabSz="1202436" rtl="0" eaLnBrk="1" latinLnBrk="0" hangingPunct="1">
        <a:lnSpc>
          <a:spcPct val="90000"/>
        </a:lnSpc>
        <a:spcBef>
          <a:spcPts val="658"/>
        </a:spcBef>
        <a:buFont typeface="Arial" panose="020B0604020202020204" pitchFamily="34" charset="0"/>
        <a:buChar char="•"/>
        <a:defRPr sz="2367" kern="1200">
          <a:solidFill>
            <a:schemeClr val="tx1"/>
          </a:solidFill>
          <a:latin typeface="+mn-lt"/>
          <a:ea typeface="+mn-ea"/>
          <a:cs typeface="+mn-cs"/>
        </a:defRPr>
      </a:lvl5pPr>
      <a:lvl6pPr marL="3306699" indent="-300609" algn="l" defTabSz="1202436" rtl="0" eaLnBrk="1" latinLnBrk="0" hangingPunct="1">
        <a:lnSpc>
          <a:spcPct val="90000"/>
        </a:lnSpc>
        <a:spcBef>
          <a:spcPts val="658"/>
        </a:spcBef>
        <a:buFont typeface="Arial" panose="020B0604020202020204" pitchFamily="34" charset="0"/>
        <a:buChar char="•"/>
        <a:defRPr sz="2367" kern="1200">
          <a:solidFill>
            <a:schemeClr val="tx1"/>
          </a:solidFill>
          <a:latin typeface="+mn-lt"/>
          <a:ea typeface="+mn-ea"/>
          <a:cs typeface="+mn-cs"/>
        </a:defRPr>
      </a:lvl6pPr>
      <a:lvl7pPr marL="3907917" indent="-300609" algn="l" defTabSz="1202436" rtl="0" eaLnBrk="1" latinLnBrk="0" hangingPunct="1">
        <a:lnSpc>
          <a:spcPct val="90000"/>
        </a:lnSpc>
        <a:spcBef>
          <a:spcPts val="658"/>
        </a:spcBef>
        <a:buFont typeface="Arial" panose="020B0604020202020204" pitchFamily="34" charset="0"/>
        <a:buChar char="•"/>
        <a:defRPr sz="2367" kern="1200">
          <a:solidFill>
            <a:schemeClr val="tx1"/>
          </a:solidFill>
          <a:latin typeface="+mn-lt"/>
          <a:ea typeface="+mn-ea"/>
          <a:cs typeface="+mn-cs"/>
        </a:defRPr>
      </a:lvl7pPr>
      <a:lvl8pPr marL="4509135" indent="-300609" algn="l" defTabSz="1202436" rtl="0" eaLnBrk="1" latinLnBrk="0" hangingPunct="1">
        <a:lnSpc>
          <a:spcPct val="90000"/>
        </a:lnSpc>
        <a:spcBef>
          <a:spcPts val="658"/>
        </a:spcBef>
        <a:buFont typeface="Arial" panose="020B0604020202020204" pitchFamily="34" charset="0"/>
        <a:buChar char="•"/>
        <a:defRPr sz="2367" kern="1200">
          <a:solidFill>
            <a:schemeClr val="tx1"/>
          </a:solidFill>
          <a:latin typeface="+mn-lt"/>
          <a:ea typeface="+mn-ea"/>
          <a:cs typeface="+mn-cs"/>
        </a:defRPr>
      </a:lvl8pPr>
      <a:lvl9pPr marL="5110353" indent="-300609" algn="l" defTabSz="1202436" rtl="0" eaLnBrk="1" latinLnBrk="0" hangingPunct="1">
        <a:lnSpc>
          <a:spcPct val="90000"/>
        </a:lnSpc>
        <a:spcBef>
          <a:spcPts val="658"/>
        </a:spcBef>
        <a:buFont typeface="Arial" panose="020B0604020202020204" pitchFamily="34" charset="0"/>
        <a:buChar char="•"/>
        <a:defRPr sz="2367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202436" rtl="0" eaLnBrk="1" latinLnBrk="0" hangingPunct="1">
        <a:defRPr sz="2367" kern="1200">
          <a:solidFill>
            <a:schemeClr val="tx1"/>
          </a:solidFill>
          <a:latin typeface="+mn-lt"/>
          <a:ea typeface="+mn-ea"/>
          <a:cs typeface="+mn-cs"/>
        </a:defRPr>
      </a:lvl1pPr>
      <a:lvl2pPr marL="601218" algn="l" defTabSz="1202436" rtl="0" eaLnBrk="1" latinLnBrk="0" hangingPunct="1">
        <a:defRPr sz="2367" kern="1200">
          <a:solidFill>
            <a:schemeClr val="tx1"/>
          </a:solidFill>
          <a:latin typeface="+mn-lt"/>
          <a:ea typeface="+mn-ea"/>
          <a:cs typeface="+mn-cs"/>
        </a:defRPr>
      </a:lvl2pPr>
      <a:lvl3pPr marL="1202436" algn="l" defTabSz="1202436" rtl="0" eaLnBrk="1" latinLnBrk="0" hangingPunct="1">
        <a:defRPr sz="2367" kern="1200">
          <a:solidFill>
            <a:schemeClr val="tx1"/>
          </a:solidFill>
          <a:latin typeface="+mn-lt"/>
          <a:ea typeface="+mn-ea"/>
          <a:cs typeface="+mn-cs"/>
        </a:defRPr>
      </a:lvl3pPr>
      <a:lvl4pPr marL="1803654" algn="l" defTabSz="1202436" rtl="0" eaLnBrk="1" latinLnBrk="0" hangingPunct="1">
        <a:defRPr sz="2367" kern="1200">
          <a:solidFill>
            <a:schemeClr val="tx1"/>
          </a:solidFill>
          <a:latin typeface="+mn-lt"/>
          <a:ea typeface="+mn-ea"/>
          <a:cs typeface="+mn-cs"/>
        </a:defRPr>
      </a:lvl4pPr>
      <a:lvl5pPr marL="2404872" algn="l" defTabSz="1202436" rtl="0" eaLnBrk="1" latinLnBrk="0" hangingPunct="1">
        <a:defRPr sz="2367" kern="1200">
          <a:solidFill>
            <a:schemeClr val="tx1"/>
          </a:solidFill>
          <a:latin typeface="+mn-lt"/>
          <a:ea typeface="+mn-ea"/>
          <a:cs typeface="+mn-cs"/>
        </a:defRPr>
      </a:lvl5pPr>
      <a:lvl6pPr marL="3006090" algn="l" defTabSz="1202436" rtl="0" eaLnBrk="1" latinLnBrk="0" hangingPunct="1">
        <a:defRPr sz="2367" kern="1200">
          <a:solidFill>
            <a:schemeClr val="tx1"/>
          </a:solidFill>
          <a:latin typeface="+mn-lt"/>
          <a:ea typeface="+mn-ea"/>
          <a:cs typeface="+mn-cs"/>
        </a:defRPr>
      </a:lvl6pPr>
      <a:lvl7pPr marL="3607308" algn="l" defTabSz="1202436" rtl="0" eaLnBrk="1" latinLnBrk="0" hangingPunct="1">
        <a:defRPr sz="2367" kern="1200">
          <a:solidFill>
            <a:schemeClr val="tx1"/>
          </a:solidFill>
          <a:latin typeface="+mn-lt"/>
          <a:ea typeface="+mn-ea"/>
          <a:cs typeface="+mn-cs"/>
        </a:defRPr>
      </a:lvl7pPr>
      <a:lvl8pPr marL="4208526" algn="l" defTabSz="1202436" rtl="0" eaLnBrk="1" latinLnBrk="0" hangingPunct="1">
        <a:defRPr sz="2367" kern="1200">
          <a:solidFill>
            <a:schemeClr val="tx1"/>
          </a:solidFill>
          <a:latin typeface="+mn-lt"/>
          <a:ea typeface="+mn-ea"/>
          <a:cs typeface="+mn-cs"/>
        </a:defRPr>
      </a:lvl8pPr>
      <a:lvl9pPr marL="4809744" algn="l" defTabSz="1202436" rtl="0" eaLnBrk="1" latinLnBrk="0" hangingPunct="1">
        <a:defRPr sz="2367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190500" y="-246508"/>
            <a:ext cx="12573000" cy="71247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4148921" y="92140"/>
            <a:ext cx="20062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ample 2</a:t>
            </a:r>
            <a:endParaRPr lang="en-IN" dirty="0"/>
          </a:p>
        </p:txBody>
      </p:sp>
      <p:sp>
        <p:nvSpPr>
          <p:cNvPr id="4" name="TextBox 3"/>
          <p:cNvSpPr txBox="1"/>
          <p:nvPr/>
        </p:nvSpPr>
        <p:spPr>
          <a:xfrm>
            <a:off x="1216927" y="92140"/>
            <a:ext cx="20062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ample 1</a:t>
            </a:r>
            <a:endParaRPr lang="en-IN" dirty="0"/>
          </a:p>
        </p:txBody>
      </p:sp>
      <p:sp>
        <p:nvSpPr>
          <p:cNvPr id="5" name="TextBox 4"/>
          <p:cNvSpPr txBox="1"/>
          <p:nvPr/>
        </p:nvSpPr>
        <p:spPr>
          <a:xfrm>
            <a:off x="7397088" y="92140"/>
            <a:ext cx="20062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ample 3</a:t>
            </a:r>
            <a:endParaRPr lang="en-IN" dirty="0"/>
          </a:p>
        </p:txBody>
      </p:sp>
      <p:sp>
        <p:nvSpPr>
          <p:cNvPr id="6" name="TextBox 5"/>
          <p:cNvSpPr txBox="1"/>
          <p:nvPr/>
        </p:nvSpPr>
        <p:spPr>
          <a:xfrm>
            <a:off x="10060676" y="92140"/>
            <a:ext cx="200622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Sample 4</a:t>
            </a:r>
            <a:endParaRPr lang="en-IN" dirty="0"/>
          </a:p>
        </p:txBody>
      </p:sp>
      <p:sp>
        <p:nvSpPr>
          <p:cNvPr id="7" name="TextBox 6"/>
          <p:cNvSpPr txBox="1"/>
          <p:nvPr/>
        </p:nvSpPr>
        <p:spPr>
          <a:xfrm rot="16200000">
            <a:off x="-370933" y="1216057"/>
            <a:ext cx="12146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re alcohol</a:t>
            </a:r>
            <a:endParaRPr lang="en-IN" dirty="0"/>
          </a:p>
        </p:txBody>
      </p:sp>
      <p:sp>
        <p:nvSpPr>
          <p:cNvPr id="9" name="TextBox 8"/>
          <p:cNvSpPr txBox="1"/>
          <p:nvPr/>
        </p:nvSpPr>
        <p:spPr>
          <a:xfrm rot="16200000">
            <a:off x="-320721" y="4207192"/>
            <a:ext cx="121465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Post alcohol</a:t>
            </a:r>
            <a:endParaRPr lang="en-IN" dirty="0"/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773FE057-5185-DF4A-9763-85C498D1B29F}"/>
              </a:ext>
            </a:extLst>
          </p:cNvPr>
          <p:cNvSpPr/>
          <p:nvPr/>
        </p:nvSpPr>
        <p:spPr>
          <a:xfrm>
            <a:off x="209267" y="6914167"/>
            <a:ext cx="11891749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Supplementary Figure 2. Viability assay of enriched PMN using Zombie Aqua fixable dye. </a:t>
            </a:r>
            <a:r>
              <a:rPr lang="en-US" dirty="0">
                <a:latin typeface="Times New Roman" panose="02020603050405020304" pitchFamily="18" charset="0"/>
                <a:cs typeface="Times New Roman" panose="02020603050405020304" pitchFamily="18" charset="0"/>
              </a:rPr>
              <a:t>A representative of 4 enriched PMN samples have been shown in this figure. The Zombie aqua dye (corresponds to BV510 channel) stains dead/late apoptotic cells, and the histogram plot indicates the percentage of live (towards left, BV510-A -) and percentage of dead (towards right, BV510-A +). Our data shows that among the enriched PMN, on an average 91.25% cells (% of total PMN) were viable before incubation with alcohol (Top panel) and on an average 95.67% of cells (% of total PMN) were viable after incubation with alcohol (Bottom panel) .</a:t>
            </a:r>
            <a:endParaRPr lang="en-IN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221471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138</Words>
  <Application>Microsoft Macintosh PowerPoint</Application>
  <PresentationFormat>Custom</PresentationFormat>
  <Paragraphs>8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enovo-pc</dc:creator>
  <cp:lastModifiedBy>Aditya Roshan</cp:lastModifiedBy>
  <cp:revision>8</cp:revision>
  <dcterms:created xsi:type="dcterms:W3CDTF">2022-05-03T09:44:25Z</dcterms:created>
  <dcterms:modified xsi:type="dcterms:W3CDTF">2023-02-03T06:52:06Z</dcterms:modified>
</cp:coreProperties>
</file>